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1" clrIdx="0">
    <p:extLst>
      <p:ext uri="{19B8F6BF-5375-455C-9EA6-DF929625EA0E}">
        <p15:presenceInfo xmlns:p15="http://schemas.microsoft.com/office/powerpoint/2012/main" userId="805fbe2f2416c41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0293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7958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0620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9633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5216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7799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2858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8817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1370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848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4458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61E8D-3301-46EF-96FA-D080F219D9B3}" type="datetimeFigureOut">
              <a:rPr lang="ko-KR" altLang="en-US" smtClean="0"/>
              <a:t>2022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A1090-F879-4707-BBF9-F608EE0DBF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9837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>
            <a:extLst>
              <a:ext uri="{FF2B5EF4-FFF2-40B4-BE49-F238E27FC236}">
                <a16:creationId xmlns:a16="http://schemas.microsoft.com/office/drawing/2014/main" id="{A0234270-DD49-9599-0980-9C9FC75406C9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10898" y="1270143"/>
            <a:ext cx="2736000" cy="165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33" name="표 14">
            <a:extLst>
              <a:ext uri="{FF2B5EF4-FFF2-40B4-BE49-F238E27FC236}">
                <a16:creationId xmlns:a16="http://schemas.microsoft.com/office/drawing/2014/main" id="{AF032170-FF85-28F8-FF9F-E8628FEAAF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5741678"/>
              </p:ext>
            </p:extLst>
          </p:nvPr>
        </p:nvGraphicFramePr>
        <p:xfrm>
          <a:off x="1780671" y="4048661"/>
          <a:ext cx="6392030" cy="173529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12253">
                  <a:extLst>
                    <a:ext uri="{9D8B030D-6E8A-4147-A177-3AD203B41FA5}">
                      <a16:colId xmlns:a16="http://schemas.microsoft.com/office/drawing/2014/main" val="1118784223"/>
                    </a:ext>
                  </a:extLst>
                </a:gridCol>
                <a:gridCol w="2811769">
                  <a:extLst>
                    <a:ext uri="{9D8B030D-6E8A-4147-A177-3AD203B41FA5}">
                      <a16:colId xmlns:a16="http://schemas.microsoft.com/office/drawing/2014/main" val="2403010435"/>
                    </a:ext>
                  </a:extLst>
                </a:gridCol>
                <a:gridCol w="8160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5200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75435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  <a:r>
                        <a:rPr lang="en-US" altLang="ko-KR" sz="10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r>
                        <a:rPr lang="en-US" altLang="ko-KR" sz="10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Probe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ction (</a:t>
                      </a:r>
                      <a:r>
                        <a:rPr lang="en-US" altLang="ko-KR" sz="10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oles</a:t>
                      </a: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 20u)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000" b="1" dirty="0"/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6985243"/>
                  </a:ext>
                </a:extLst>
              </a:tr>
              <a:tr h="37543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 b="0" dirty="0"/>
                    </a:p>
                  </a:txBody>
                  <a:tcPr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2965746"/>
                  </a:ext>
                </a:extLst>
              </a:tr>
              <a:tr h="246862">
                <a:tc row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54H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id19-Q954H-F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0078595"/>
                  </a:ext>
                </a:extLst>
              </a:tr>
              <a:tr h="24686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id19-Q954H-R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686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-Covid19-Q954H-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3651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 b="0" dirty="0"/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ovid19-954Q-com</a:t>
                      </a:r>
                      <a:r>
                        <a:rPr lang="en-US" altLang="ko-KR" sz="10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2</a:t>
                      </a:r>
                      <a:endParaRPr lang="en-US" altLang="ko-KR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alt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7607764"/>
                  </a:ext>
                </a:extLst>
              </a:tr>
            </a:tbl>
          </a:graphicData>
        </a:graphic>
      </p:graphicFrame>
      <p:sp>
        <p:nvSpPr>
          <p:cNvPr id="34" name="직사각형 33">
            <a:extLst>
              <a:ext uri="{FF2B5EF4-FFF2-40B4-BE49-F238E27FC236}">
                <a16:creationId xmlns:a16="http://schemas.microsoft.com/office/drawing/2014/main" id="{3ACA17DC-CA1D-483C-E397-CAD74A9A6578}"/>
              </a:ext>
            </a:extLst>
          </p:cNvPr>
          <p:cNvSpPr/>
          <p:nvPr/>
        </p:nvSpPr>
        <p:spPr>
          <a:xfrm>
            <a:off x="2157935" y="1023392"/>
            <a:ext cx="16466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ctr">
              <a:defRPr/>
            </a:pP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FAM-Covid19-Q954H-3</a:t>
            </a:r>
          </a:p>
        </p:txBody>
      </p: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8A671224-B7D6-8623-ECE4-246C58CAE59D}"/>
              </a:ext>
            </a:extLst>
          </p:cNvPr>
          <p:cNvSpPr/>
          <p:nvPr/>
        </p:nvSpPr>
        <p:spPr>
          <a:xfrm>
            <a:off x="4908682" y="1009559"/>
            <a:ext cx="26981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ctr">
              <a:defRPr/>
            </a:pP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FAM-Covid19-Q954H-3+ com-2  20 </a:t>
            </a:r>
            <a:r>
              <a:rPr lang="en-US" altLang="ko-K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oles</a:t>
            </a:r>
            <a:endParaRPr lang="en-US" altLang="ko-K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Picture 8">
            <a:extLst>
              <a:ext uri="{FF2B5EF4-FFF2-40B4-BE49-F238E27FC236}">
                <a16:creationId xmlns:a16="http://schemas.microsoft.com/office/drawing/2014/main" id="{8F3AB950-0016-7271-2357-558383ABFFF9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87826" y="1277741"/>
            <a:ext cx="2736000" cy="165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8" name="직사각형 37">
            <a:extLst>
              <a:ext uri="{FF2B5EF4-FFF2-40B4-BE49-F238E27FC236}">
                <a16:creationId xmlns:a16="http://schemas.microsoft.com/office/drawing/2014/main" id="{E2750087-5DD7-0DB4-268E-08887FFB61B2}"/>
              </a:ext>
            </a:extLst>
          </p:cNvPr>
          <p:cNvSpPr/>
          <p:nvPr/>
        </p:nvSpPr>
        <p:spPr>
          <a:xfrm>
            <a:off x="7541936" y="1503247"/>
            <a:ext cx="732893" cy="116955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endParaRPr lang="ko-KR" altLang="en-US" sz="1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endParaRPr lang="ko-KR" altLang="en-US" sz="1000" b="1" dirty="0">
              <a:solidFill>
                <a:srgbClr val="FFC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ko-KR" altLang="en-US" sz="10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ko-KR" altLang="en-US" sz="1000" b="1" dirty="0">
              <a:solidFill>
                <a:srgbClr val="00B0F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ko-KR" altLang="en-US" sz="10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ko-KR" altLang="en-US" sz="1000" b="1" dirty="0">
              <a:solidFill>
                <a:srgbClr val="FF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dirty="0">
                <a:solidFill>
                  <a:srgbClr val="9148C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4Q  10</a:t>
            </a:r>
            <a:r>
              <a:rPr lang="en-US" altLang="ko-KR" sz="1000" b="1" baseline="30000" dirty="0">
                <a:solidFill>
                  <a:srgbClr val="9148C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ko-KR" altLang="en-US" sz="1000" b="1" dirty="0">
              <a:solidFill>
                <a:srgbClr val="9148C8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직사각형 38">
            <a:extLst>
              <a:ext uri="{FF2B5EF4-FFF2-40B4-BE49-F238E27FC236}">
                <a16:creationId xmlns:a16="http://schemas.microsoft.com/office/drawing/2014/main" id="{1C7D0A2D-CD60-6B54-00C6-41F21902410D}"/>
              </a:ext>
            </a:extLst>
          </p:cNvPr>
          <p:cNvSpPr/>
          <p:nvPr/>
        </p:nvSpPr>
        <p:spPr>
          <a:xfrm>
            <a:off x="1989935" y="1980301"/>
            <a:ext cx="82907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shold : </a:t>
            </a:r>
            <a:r>
              <a:rPr lang="en-US" altLang="ko-KR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8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01FBDE02-4793-E7F0-2936-1F1BCB5A499F}"/>
              </a:ext>
            </a:extLst>
          </p:cNvPr>
          <p:cNvSpPr/>
          <p:nvPr/>
        </p:nvSpPr>
        <p:spPr>
          <a:xfrm>
            <a:off x="5118159" y="2213845"/>
            <a:ext cx="83388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shold : </a:t>
            </a:r>
            <a:r>
              <a:rPr lang="en-US" altLang="ko-KR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8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표 2">
            <a:extLst>
              <a:ext uri="{FF2B5EF4-FFF2-40B4-BE49-F238E27FC236}">
                <a16:creationId xmlns:a16="http://schemas.microsoft.com/office/drawing/2014/main" id="{7AA87072-AACC-5DA1-AEB2-25499CD017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8032687"/>
              </p:ext>
            </p:extLst>
          </p:nvPr>
        </p:nvGraphicFramePr>
        <p:xfrm>
          <a:off x="1780672" y="2983644"/>
          <a:ext cx="6392031" cy="914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49053">
                  <a:extLst>
                    <a:ext uri="{9D8B030D-6E8A-4147-A177-3AD203B41FA5}">
                      <a16:colId xmlns:a16="http://schemas.microsoft.com/office/drawing/2014/main" val="2510397747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3501402661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307136496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883345029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3828393987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3792872548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3163838707"/>
                    </a:ext>
                  </a:extLst>
                </a:gridCol>
                <a:gridCol w="591854">
                  <a:extLst>
                    <a:ext uri="{9D8B030D-6E8A-4147-A177-3AD203B41FA5}">
                      <a16:colId xmlns:a16="http://schemas.microsoft.com/office/drawing/2014/main" val="3084569238"/>
                    </a:ext>
                  </a:extLst>
                </a:gridCol>
              </a:tblGrid>
              <a:tr h="205377">
                <a:tc rowSpan="2">
                  <a:txBody>
                    <a:bodyPr/>
                    <a:lstStyle/>
                    <a:p>
                      <a:pPr latinLnBrk="1"/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 value </a:t>
                      </a:r>
                      <a:r>
                        <a:rPr lang="en-US" altLang="ko-KR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verage of 2-repeats)</a:t>
                      </a:r>
                      <a:endParaRPr lang="ko-KR" alt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2629408"/>
                  </a:ext>
                </a:extLst>
              </a:tr>
              <a:tr h="205377">
                <a:tc vMerge="1">
                  <a:txBody>
                    <a:bodyPr/>
                    <a:lstStyle/>
                    <a:p>
                      <a:pPr latinLnBrk="1"/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altLang="ko-KR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9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kumimoji="0" lang="en-US" altLang="ko-KR" sz="9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</a:t>
                      </a:r>
                      <a:endParaRPr kumimoji="0" lang="ko-KR" altLang="en-US" sz="900" b="0" i="0" u="none" strike="noStrike" kern="120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kumimoji="0" lang="en-US" altLang="ko-KR" sz="9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</a:t>
                      </a:r>
                      <a:endParaRPr kumimoji="0" lang="ko-KR" altLang="en-US" sz="900" b="0" i="0" u="none" strike="noStrike" kern="120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kumimoji="0" lang="en-US" altLang="ko-KR" sz="9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</a:t>
                      </a:r>
                      <a:endParaRPr kumimoji="0" lang="ko-KR" altLang="en-US" sz="900" b="0" i="0" u="none" strike="noStrike" kern="120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kumimoji="0" lang="en-US" altLang="ko-KR" sz="9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</a:t>
                      </a:r>
                      <a:endParaRPr kumimoji="0" lang="ko-KR" altLang="en-US" sz="900" b="0" i="0" u="none" strike="noStrike" kern="120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kumimoji="0" lang="en-US" altLang="ko-KR" sz="9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</a:t>
                      </a:r>
                      <a:endParaRPr kumimoji="0" lang="ko-KR" altLang="en-US" sz="900" b="0" i="0" u="none" strike="noStrike" kern="120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kumimoji="0" lang="en-US" altLang="ko-KR" sz="9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kumimoji="0" lang="ko-KR" altLang="en-US" sz="900" b="0" i="0" u="none" strike="noStrike" kern="120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18300038"/>
                  </a:ext>
                </a:extLst>
              </a:tr>
              <a:tr h="20537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-Covid19-Q954H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6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2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5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81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92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38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13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22994981"/>
                  </a:ext>
                </a:extLst>
              </a:tr>
              <a:tr h="20537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-Covid19-Q954H-3+ com-2  20 </a:t>
                      </a:r>
                      <a:r>
                        <a:rPr lang="en-US" altLang="ko-KR" sz="9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oles</a:t>
                      </a:r>
                      <a:endParaRPr lang="en-US" altLang="ko-KR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D</a:t>
                      </a:r>
                      <a:endParaRPr kumimoji="0" lang="ko-KR" alt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D</a:t>
                      </a:r>
                      <a:endParaRPr kumimoji="0" lang="ko-KR" alt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D</a:t>
                      </a:r>
                      <a:endParaRPr kumimoji="0" lang="ko-KR" alt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D</a:t>
                      </a:r>
                      <a:endParaRPr kumimoji="0" lang="ko-KR" alt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D</a:t>
                      </a:r>
                      <a:endParaRPr kumimoji="0" lang="ko-KR" alt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D</a:t>
                      </a:r>
                      <a:endParaRPr kumimoji="0" lang="ko-KR" alt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987633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94529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88</Words>
  <Application>Microsoft Office PowerPoint</Application>
  <PresentationFormat>화면 슬라이드 쇼(4:3)</PresentationFormat>
  <Paragraphs>5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9</cp:revision>
  <dcterms:created xsi:type="dcterms:W3CDTF">2022-05-17T06:15:01Z</dcterms:created>
  <dcterms:modified xsi:type="dcterms:W3CDTF">2022-11-14T01:29:23Z</dcterms:modified>
</cp:coreProperties>
</file>